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8654" autoAdjust="0"/>
  </p:normalViewPr>
  <p:slideViewPr>
    <p:cSldViewPr snapToGrid="0" snapToObjects="1">
      <p:cViewPr>
        <p:scale>
          <a:sx n="112" d="100"/>
          <a:sy n="112" d="100"/>
        </p:scale>
        <p:origin x="-1464" y="80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576A9-3BA8-7743-807C-18B89439BFEE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F5D1F-3262-4D4D-8779-6D16CD245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5465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576A9-3BA8-7743-807C-18B89439BFEE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F5D1F-3262-4D4D-8779-6D16CD245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638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576A9-3BA8-7743-807C-18B89439BFEE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F5D1F-3262-4D4D-8779-6D16CD245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58978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576A9-3BA8-7743-807C-18B89439BFEE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F5D1F-3262-4D4D-8779-6D16CD245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3639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576A9-3BA8-7743-807C-18B89439BFEE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F5D1F-3262-4D4D-8779-6D16CD245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547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576A9-3BA8-7743-807C-18B89439BFEE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F5D1F-3262-4D4D-8779-6D16CD245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83638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576A9-3BA8-7743-807C-18B89439BFEE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F5D1F-3262-4D4D-8779-6D16CD245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833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576A9-3BA8-7743-807C-18B89439BFEE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F5D1F-3262-4D4D-8779-6D16CD245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16893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576A9-3BA8-7743-807C-18B89439BFEE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F5D1F-3262-4D4D-8779-6D16CD245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1104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576A9-3BA8-7743-807C-18B89439BFEE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F5D1F-3262-4D4D-8779-6D16CD245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6218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576A9-3BA8-7743-807C-18B89439BFEE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F5D1F-3262-4D4D-8779-6D16CD245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7050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A576A9-3BA8-7743-807C-18B89439BFEE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9F5D1F-3262-4D4D-8779-6D16CD2453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4952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4570708" y="8774668"/>
            <a:ext cx="228729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/>
              <a:t>S2 Fig. </a:t>
            </a:r>
            <a:r>
              <a:rPr lang="en-US" altLang="ja-JP" dirty="0" err="1" smtClean="0"/>
              <a:t>Suzukawa</a:t>
            </a:r>
            <a:r>
              <a:rPr lang="en-US" altLang="ja-JP" dirty="0" smtClean="0"/>
              <a:t> et </a:t>
            </a:r>
            <a:r>
              <a:rPr lang="en-US" altLang="ja-JP" dirty="0"/>
              <a:t>al.</a:t>
            </a:r>
            <a:endParaRPr lang="ja-JP" altLang="en-US" dirty="0"/>
          </a:p>
        </p:txBody>
      </p:sp>
      <p:pic>
        <p:nvPicPr>
          <p:cNvPr id="6" name="図 5" descr="1 - for new fig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700" y="1708150"/>
            <a:ext cx="5816600" cy="5727700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750507" y="7345133"/>
            <a:ext cx="558679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"/>
                <a:cs typeface="Arial"/>
              </a:rPr>
              <a:t>S2 Fig. </a:t>
            </a:r>
            <a:r>
              <a:rPr lang="en-US" altLang="ja-JP" sz="1200" dirty="0">
                <a:latin typeface="Arial"/>
                <a:cs typeface="Arial"/>
              </a:rPr>
              <a:t>Top four ROC curves comparing the diagnostic accuracy of cytokines in Nil supernatants for differentiating active TB from LTBI. AUCs for each cytokine are shown in the graph.</a:t>
            </a:r>
            <a:endParaRPr lang="ja-JP" altLang="ja-JP" sz="1200" dirty="0">
              <a:latin typeface="Arial"/>
              <a:cs typeface="Arial"/>
            </a:endParaRPr>
          </a:p>
          <a:p>
            <a:endParaRPr kumimoji="1" lang="ja-JP" alt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5246862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8</TotalTime>
  <Words>40</Words>
  <Application>Microsoft Macintosh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川 真穂</dc:creator>
  <cp:lastModifiedBy>鈴川 真穂</cp:lastModifiedBy>
  <cp:revision>10</cp:revision>
  <dcterms:created xsi:type="dcterms:W3CDTF">2015-08-19T00:45:04Z</dcterms:created>
  <dcterms:modified xsi:type="dcterms:W3CDTF">2016-03-18T02:38:13Z</dcterms:modified>
</cp:coreProperties>
</file>